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7" r:id="rId3"/>
    <p:sldId id="258" r:id="rId4"/>
    <p:sldId id="259" r:id="rId5"/>
    <p:sldId id="260" r:id="rId6"/>
    <p:sldId id="261" r:id="rId7"/>
    <p:sldId id="262" r:id="rId8"/>
    <p:sldId id="264" r:id="rId9"/>
    <p:sldId id="265" r:id="rId10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80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0618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057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1522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4400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4380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385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1050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0968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8915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6752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28191-3042-49F1-A0E0-03443FEAEA44}" type="datetimeFigureOut">
              <a:rPr lang="ko-KR" altLang="en-US" smtClean="0"/>
              <a:t>2020-05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39518-140E-4570-BB40-961CAB6FE2B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6861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28A4ABFC-2208-41C9-85D4-20A13A323B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05350" y="2272966"/>
            <a:ext cx="5181299" cy="136815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169198" y="3943350"/>
            <a:ext cx="8084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igure S1. Experimental schedule of UV irradiation intensity and time. 75 to 300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mJ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/cm</a:t>
            </a:r>
            <a:r>
              <a:rPr lang="en-US" altLang="ko-KR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was range of UV irradiation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59599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8CE6F983-6D99-441D-8CA1-76431458D42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47613" y="893490"/>
            <a:ext cx="4186939" cy="344272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099C3E3-6B00-4725-B149-E9558A6D7176}"/>
              </a:ext>
            </a:extLst>
          </p:cNvPr>
          <p:cNvSpPr txBox="1"/>
          <p:nvPr/>
        </p:nvSpPr>
        <p:spPr>
          <a:xfrm>
            <a:off x="9804423" y="6488668"/>
            <a:ext cx="2387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data 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3056239" y="4355809"/>
            <a:ext cx="70365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igure S2. Total phenolic and flavonoid contents of DW extract of 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Nypa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fruticans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NFD) and 100%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EtOH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extract of 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Nypa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fruticans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NFE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53510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F9DE2634-F3DE-4680-AFD8-6AAF910447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0020" y="1612058"/>
            <a:ext cx="3633027" cy="241476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099C3E3-6B00-4725-B149-E9558A6D7176}"/>
              </a:ext>
            </a:extLst>
          </p:cNvPr>
          <p:cNvSpPr txBox="1"/>
          <p:nvPr/>
        </p:nvSpPr>
        <p:spPr>
          <a:xfrm>
            <a:off x="9804423" y="6488668"/>
            <a:ext cx="2387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data 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" name="TextBox 3"/>
              <p:cNvSpPr txBox="1"/>
              <p:nvPr/>
            </p:nvSpPr>
            <p:spPr>
              <a:xfrm>
                <a:off x="2645742" y="4355544"/>
                <a:ext cx="715868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igure S3.  DPPH-radical scavenging activity of NFD and NFE. Ascorbic acid were used as positive control. The results are shown as means </a:t>
                </a:r>
                <a14:m>
                  <m:oMath xmlns:m="http://schemas.openxmlformats.org/officeDocument/2006/math">
                    <m:r>
                      <a:rPr lang="en-US" altLang="ko-KR" sz="1200">
                        <a:latin typeface="Cambria Math"/>
                      </a:rPr>
                      <m:t>±</m:t>
                    </m:r>
                  </m:oMath>
                </a14:m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SD performed in triplicates (** </a:t>
                </a:r>
                <a:r>
                  <a:rPr lang="en-US" altLang="ko-KR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5). 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4" name="TextBox 3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645742" y="4355544"/>
                <a:ext cx="7158681" cy="461665"/>
              </a:xfrm>
              <a:prstGeom prst="rect">
                <a:avLst/>
              </a:prstGeom>
              <a:blipFill rotWithShape="0">
                <a:blip r:embed="rId3"/>
                <a:stretch>
                  <a:fillRect t="-1316" r="-85" b="-7895"/>
                </a:stretch>
              </a:blipFill>
            </p:spPr>
            <p:txBody>
              <a:bodyPr/>
              <a:lstStyle/>
              <a:p>
                <a:r>
                  <a:rPr lang="ko-KR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0592156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CAAAF965-F666-4B6E-9EF0-BEDAC4D6C4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37055" y="1504965"/>
            <a:ext cx="3839463" cy="264983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099C3E3-6B00-4725-B149-E9558A6D7176}"/>
              </a:ext>
            </a:extLst>
          </p:cNvPr>
          <p:cNvSpPr txBox="1"/>
          <p:nvPr/>
        </p:nvSpPr>
        <p:spPr>
          <a:xfrm>
            <a:off x="9804423" y="6488668"/>
            <a:ext cx="2387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data 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" name="TextBox 3"/>
              <p:cNvSpPr txBox="1"/>
              <p:nvPr/>
            </p:nvSpPr>
            <p:spPr>
              <a:xfrm>
                <a:off x="2496065" y="4396734"/>
                <a:ext cx="705158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igure S4. Effects of ABTS-radical inhibition activity by NFD and NFE. Ascorbic acid were used as positive control. The results are shown as means </a:t>
                </a:r>
                <a14:m>
                  <m:oMath xmlns:m="http://schemas.openxmlformats.org/officeDocument/2006/math">
                    <m:r>
                      <a:rPr lang="en-US" altLang="ko-KR" sz="1200">
                        <a:latin typeface="Cambria Math"/>
                      </a:rPr>
                      <m:t>±</m:t>
                    </m:r>
                  </m:oMath>
                </a14:m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SD performed in triplicates (** </a:t>
                </a:r>
                <a:r>
                  <a:rPr lang="en-US" altLang="ko-KR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5). 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4" name="TextBox 3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496065" y="4396734"/>
                <a:ext cx="7051589" cy="461665"/>
              </a:xfrm>
              <a:prstGeom prst="rect">
                <a:avLst/>
              </a:prstGeom>
              <a:blipFill rotWithShape="0">
                <a:blip r:embed="rId3"/>
                <a:stretch>
                  <a:fillRect t="-1316" b="-7895"/>
                </a:stretch>
              </a:blipFill>
            </p:spPr>
            <p:txBody>
              <a:bodyPr/>
              <a:lstStyle/>
              <a:p>
                <a:r>
                  <a:rPr lang="ko-KR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12721737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8B345195-3834-4D72-98F9-129969DCE9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10681" y="1438900"/>
            <a:ext cx="3339710" cy="238913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099C3E3-6B00-4725-B149-E9558A6D7176}"/>
              </a:ext>
            </a:extLst>
          </p:cNvPr>
          <p:cNvSpPr txBox="1"/>
          <p:nvPr/>
        </p:nvSpPr>
        <p:spPr>
          <a:xfrm>
            <a:off x="9804423" y="6488668"/>
            <a:ext cx="2387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data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53946" y="4042508"/>
            <a:ext cx="60827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igure S5. Reducing antioxidant capacity of NFD and NFE. It was calculated by ascorbic acid equivalent value (µM)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18397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F099C3E3-6B00-4725-B149-E9558A6D7176}"/>
              </a:ext>
            </a:extLst>
          </p:cNvPr>
          <p:cNvSpPr txBox="1"/>
          <p:nvPr/>
        </p:nvSpPr>
        <p:spPr>
          <a:xfrm>
            <a:off x="9804423" y="6488668"/>
            <a:ext cx="2387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data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A518D43-1C10-4C92-9E46-E4754A9DAC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99711" y="1613595"/>
            <a:ext cx="3549619" cy="2402094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4" name="TextBox 3"/>
              <p:cNvSpPr txBox="1"/>
              <p:nvPr/>
            </p:nvSpPr>
            <p:spPr>
              <a:xfrm>
                <a:off x="3141296" y="4315349"/>
                <a:ext cx="590940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igure S6. Elastase inhibition activity of  NFD and NFE. EGCG was used as positive control. The results are shown as means </a:t>
                </a:r>
                <a14:m>
                  <m:oMath xmlns:m="http://schemas.openxmlformats.org/officeDocument/2006/math">
                    <m:r>
                      <a:rPr lang="en-US" altLang="ko-KR" sz="1200">
                        <a:latin typeface="Cambria Math"/>
                      </a:rPr>
                      <m:t>±</m:t>
                    </m:r>
                  </m:oMath>
                </a14:m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SD performed in triplicates (** </a:t>
                </a:r>
                <a:r>
                  <a:rPr lang="en-US" altLang="ko-KR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ko-K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5). </a:t>
                </a:r>
                <a:endParaRPr lang="ko-KR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4" name="TextBox 3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141296" y="4315349"/>
                <a:ext cx="5909407" cy="461665"/>
              </a:xfrm>
              <a:prstGeom prst="rect">
                <a:avLst/>
              </a:prstGeom>
              <a:blipFill rotWithShape="0">
                <a:blip r:embed="rId3"/>
                <a:stretch>
                  <a:fillRect t="-2632" b="-7895"/>
                </a:stretch>
              </a:blipFill>
            </p:spPr>
            <p:txBody>
              <a:bodyPr/>
              <a:lstStyle/>
              <a:p>
                <a:r>
                  <a:rPr lang="ko-KR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0390072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F099C3E3-6B00-4725-B149-E9558A6D7176}"/>
              </a:ext>
            </a:extLst>
          </p:cNvPr>
          <p:cNvSpPr txBox="1"/>
          <p:nvPr/>
        </p:nvSpPr>
        <p:spPr>
          <a:xfrm>
            <a:off x="9804423" y="6488668"/>
            <a:ext cx="2387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data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39BD2AD-FE36-48DF-9D6D-AE633CBEB1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2544" y="1201822"/>
            <a:ext cx="3806912" cy="243492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832674" y="3877750"/>
            <a:ext cx="41667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igure S7. Cell viability of NFD and NFE</a:t>
            </a:r>
            <a:r>
              <a:rPr lang="ko-KR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using MTT assay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51061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696287" y="4152038"/>
            <a:ext cx="53569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igure S8. Effect of NF50E on mRNA expression of Col1a1, MMP-8 and -13 were done by RT-PCR analysis.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그림 8">
            <a:extLst>
              <a:ext uri="{FF2B5EF4-FFF2-40B4-BE49-F238E27FC236}">
                <a16:creationId xmlns:a16="http://schemas.microsoft.com/office/drawing/2014/main" id="{73C197B5-AA43-4D64-8D79-535B01601D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68502" y="2213643"/>
            <a:ext cx="2557091" cy="1517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02076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3746905" y="3765280"/>
            <a:ext cx="53569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igure S9. Phosphorylation of ERK by NF50E was performed by western blot analysis.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그림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6762" y="1751923"/>
            <a:ext cx="3038475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4883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7</TotalTime>
  <Words>242</Words>
  <Application>Microsoft Office PowerPoint</Application>
  <PresentationFormat>와이드스크린</PresentationFormat>
  <Paragraphs>15</Paragraphs>
  <Slides>9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3" baseType="lpstr">
      <vt:lpstr>맑은 고딕</vt:lpstr>
      <vt:lpstr>Arial</vt:lpstr>
      <vt:lpstr>Cambria Math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희정</dc:creator>
  <cp:lastModifiedBy>희정</cp:lastModifiedBy>
  <cp:revision>12</cp:revision>
  <dcterms:created xsi:type="dcterms:W3CDTF">2019-11-29T02:44:56Z</dcterms:created>
  <dcterms:modified xsi:type="dcterms:W3CDTF">2020-05-15T07:24:32Z</dcterms:modified>
</cp:coreProperties>
</file>